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40" userDrawn="1">
          <p15:clr>
            <a:srgbClr val="A4A3A4"/>
          </p15:clr>
        </p15:guide>
        <p15:guide id="2" pos="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2558" autoAdjust="0"/>
  </p:normalViewPr>
  <p:slideViewPr>
    <p:cSldViewPr snapToGrid="0" showGuides="1">
      <p:cViewPr varScale="1">
        <p:scale>
          <a:sx n="76" d="100"/>
          <a:sy n="76" d="100"/>
        </p:scale>
        <p:origin x="3156" y="102"/>
      </p:cViewPr>
      <p:guideLst>
        <p:guide orient="horz" pos="5640"/>
        <p:guide pos="4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77079E-AC8B-45B7-8F37-FBE28EF06B10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247613-D000-4C4F-B496-C1F93ACCB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07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742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178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0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189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484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168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404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335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944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1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213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135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143109" y="36531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143109" y="25778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5A6811B-E496-4006-AC68-60A12AF82F25}"/>
              </a:ext>
            </a:extLst>
          </p:cNvPr>
          <p:cNvGrpSpPr/>
          <p:nvPr/>
        </p:nvGrpSpPr>
        <p:grpSpPr>
          <a:xfrm>
            <a:off x="1967331" y="457326"/>
            <a:ext cx="1775994" cy="2115528"/>
            <a:chOff x="1814931" y="467067"/>
            <a:chExt cx="1775994" cy="2115528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069BDE4-41C9-4234-A40A-C7638DE173D6}"/>
                </a:ext>
              </a:extLst>
            </p:cNvPr>
            <p:cNvSpPr txBox="1"/>
            <p:nvPr/>
          </p:nvSpPr>
          <p:spPr>
            <a:xfrm>
              <a:off x="2511190" y="467067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graphicFrame>
          <p:nvGraphicFramePr>
            <p:cNvPr id="35" name="Object 3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71605297"/>
                </p:ext>
              </p:extLst>
            </p:nvPr>
          </p:nvGraphicFramePr>
          <p:xfrm>
            <a:off x="2216150" y="944779"/>
            <a:ext cx="1374775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66" name="Prism 9" r:id="rId3" imgW="2181702" imgH="1498601" progId="Prism9.Document">
                    <p:embed/>
                  </p:oleObj>
                </mc:Choice>
                <mc:Fallback>
                  <p:oleObj name="Prism 9" r:id="rId3" imgW="2181702" imgH="1498601" progId="Prism9.Document">
                    <p:embed/>
                    <p:pic>
                      <p:nvPicPr>
                        <p:cNvPr id="232" name="Object 231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216150" y="944779"/>
                          <a:ext cx="1374775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A74E6AC-EFC1-45EE-91FE-BB9A0E65DF0B}"/>
                </a:ext>
              </a:extLst>
            </p:cNvPr>
            <p:cNvSpPr txBox="1"/>
            <p:nvPr/>
          </p:nvSpPr>
          <p:spPr>
            <a:xfrm rot="16200000">
              <a:off x="1288024" y="1556133"/>
              <a:ext cx="1330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G (mg/g tissue)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939258" y="142068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946942" y="107371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020723" y="1829617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366033" y="1947544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645013" y="1909222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924999" y="1229558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192634" y="1256549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2843412" y="2305596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2355551" y="2305596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50" name="Straight Connector 149"/>
            <p:cNvCxnSpPr/>
            <p:nvPr/>
          </p:nvCxnSpPr>
          <p:spPr>
            <a:xfrm>
              <a:off x="2456396" y="2349859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Connector 150"/>
            <p:cNvCxnSpPr/>
            <p:nvPr/>
          </p:nvCxnSpPr>
          <p:spPr>
            <a:xfrm>
              <a:off x="2969557" y="2349859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2" name="Group 171"/>
            <p:cNvGrpSpPr/>
            <p:nvPr/>
          </p:nvGrpSpPr>
          <p:grpSpPr>
            <a:xfrm>
              <a:off x="2345285" y="907865"/>
              <a:ext cx="563416" cy="368592"/>
              <a:chOff x="965450" y="3115553"/>
              <a:chExt cx="563416" cy="368592"/>
            </a:xfrm>
          </p:grpSpPr>
          <p:sp>
            <p:nvSpPr>
              <p:cNvPr id="173" name="Rectangle 172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4" name="TextBox 173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75" name="TextBox 174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76" name="Rectangle 175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919DCE88-4C13-4501-834F-37DFD3BCF681}"/>
              </a:ext>
            </a:extLst>
          </p:cNvPr>
          <p:cNvGrpSpPr/>
          <p:nvPr/>
        </p:nvGrpSpPr>
        <p:grpSpPr>
          <a:xfrm>
            <a:off x="241833" y="2655711"/>
            <a:ext cx="1705592" cy="2313171"/>
            <a:chOff x="201886" y="2655711"/>
            <a:chExt cx="1705592" cy="2313171"/>
          </a:xfrm>
        </p:grpSpPr>
        <p:sp>
          <p:nvSpPr>
            <p:cNvPr id="16" name="TextBox 15"/>
            <p:cNvSpPr txBox="1"/>
            <p:nvPr/>
          </p:nvSpPr>
          <p:spPr>
            <a:xfrm>
              <a:off x="391778" y="426023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86819" y="396290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91559" y="363903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86233" y="33264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94577" y="303794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A74E6AC-EFC1-45EE-91FE-BB9A0E65DF0B}"/>
                </a:ext>
              </a:extLst>
            </p:cNvPr>
            <p:cNvSpPr txBox="1"/>
            <p:nvPr/>
          </p:nvSpPr>
          <p:spPr>
            <a:xfrm rot="16200000">
              <a:off x="-320212" y="3708923"/>
              <a:ext cx="1321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C (mg/g tissue)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7E6FA13-F79D-4954-99CA-FC4547F7F4EB}"/>
                </a:ext>
              </a:extLst>
            </p:cNvPr>
            <p:cNvSpPr txBox="1"/>
            <p:nvPr/>
          </p:nvSpPr>
          <p:spPr>
            <a:xfrm>
              <a:off x="871536" y="2655711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graphicFrame>
          <p:nvGraphicFramePr>
            <p:cNvPr id="48" name="Object 4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056958"/>
                </p:ext>
              </p:extLst>
            </p:nvPr>
          </p:nvGraphicFramePr>
          <p:xfrm>
            <a:off x="507323" y="2835438"/>
            <a:ext cx="1400155" cy="20239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67" name="Prism 9" r:id="rId5" imgW="2292984" imgH="1507965" progId="Prism9.Document">
                    <p:embed/>
                  </p:oleObj>
                </mc:Choice>
                <mc:Fallback>
                  <p:oleObj name="Prism 9" r:id="rId5" imgW="2292984" imgH="1507965" progId="Prism9.Document">
                    <p:embed/>
                    <p:pic>
                      <p:nvPicPr>
                        <p:cNvPr id="245" name="Object 244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07323" y="2835438"/>
                          <a:ext cx="1400155" cy="20239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9" name="TextBox 48"/>
            <p:cNvSpPr txBox="1"/>
            <p:nvPr/>
          </p:nvSpPr>
          <p:spPr>
            <a:xfrm>
              <a:off x="635412" y="3715135"/>
              <a:ext cx="2789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832799" y="3551842"/>
              <a:ext cx="6601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,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190835" y="3295551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363528" y="3260572"/>
              <a:ext cx="4315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,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106309" y="4691883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618448" y="4691883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54" name="Straight Connector 153"/>
            <p:cNvCxnSpPr/>
            <p:nvPr/>
          </p:nvCxnSpPr>
          <p:spPr>
            <a:xfrm>
              <a:off x="719293" y="4736146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>
              <a:off x="1232454" y="4736146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7" name="Group 176"/>
            <p:cNvGrpSpPr/>
            <p:nvPr/>
          </p:nvGrpSpPr>
          <p:grpSpPr>
            <a:xfrm>
              <a:off x="624490" y="2891437"/>
              <a:ext cx="563416" cy="368592"/>
              <a:chOff x="965450" y="3115553"/>
              <a:chExt cx="563416" cy="368592"/>
            </a:xfrm>
          </p:grpSpPr>
          <p:sp>
            <p:nvSpPr>
              <p:cNvPr id="178" name="Rectangle 177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9" name="TextBox 178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80" name="TextBox 179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81" name="Rectangle 180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71718EFD-5F7A-4265-A783-E441148D3F5A}"/>
              </a:ext>
            </a:extLst>
          </p:cNvPr>
          <p:cNvGrpSpPr/>
          <p:nvPr/>
        </p:nvGrpSpPr>
        <p:grpSpPr>
          <a:xfrm>
            <a:off x="2058991" y="2680211"/>
            <a:ext cx="1591198" cy="2264170"/>
            <a:chOff x="1902203" y="2655710"/>
            <a:chExt cx="1591198" cy="2264170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069BDE4-41C9-4234-A40A-C7638DE173D6}"/>
                </a:ext>
              </a:extLst>
            </p:cNvPr>
            <p:cNvSpPr txBox="1"/>
            <p:nvPr/>
          </p:nvSpPr>
          <p:spPr>
            <a:xfrm>
              <a:off x="2409277" y="2655710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graphicFrame>
          <p:nvGraphicFramePr>
            <p:cNvPr id="53" name="Object 5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76426536"/>
                </p:ext>
              </p:extLst>
            </p:nvPr>
          </p:nvGraphicFramePr>
          <p:xfrm>
            <a:off x="2192115" y="3007082"/>
            <a:ext cx="1301286" cy="17815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68" name="Prism 9" r:id="rId7" imgW="2085546" imgH="1507965" progId="Prism9.Document">
                    <p:embed/>
                  </p:oleObj>
                </mc:Choice>
                <mc:Fallback>
                  <p:oleObj name="Prism 9" r:id="rId7" imgW="2085546" imgH="1507965" progId="Prism9.Document">
                    <p:embed/>
                    <p:pic>
                      <p:nvPicPr>
                        <p:cNvPr id="250" name="Object 249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192115" y="3007082"/>
                          <a:ext cx="1301286" cy="17815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4" name="TextBox 53"/>
            <p:cNvSpPr txBox="1"/>
            <p:nvPr/>
          </p:nvSpPr>
          <p:spPr>
            <a:xfrm>
              <a:off x="2067580" y="424519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067580" y="398758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064420" y="370907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A74E6AC-EFC1-45EE-91FE-BB9A0E65DF0B}"/>
                </a:ext>
              </a:extLst>
            </p:cNvPr>
            <p:cNvSpPr txBox="1"/>
            <p:nvPr/>
          </p:nvSpPr>
          <p:spPr>
            <a:xfrm rot="16200000">
              <a:off x="1380105" y="3743318"/>
              <a:ext cx="1321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C (mg/g tissue)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063089" y="343457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071600" y="316102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2779326" y="4642881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2291465" y="4642881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58" name="Straight Connector 157"/>
            <p:cNvCxnSpPr/>
            <p:nvPr/>
          </p:nvCxnSpPr>
          <p:spPr>
            <a:xfrm>
              <a:off x="2392310" y="4687144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Connector 158"/>
            <p:cNvCxnSpPr/>
            <p:nvPr/>
          </p:nvCxnSpPr>
          <p:spPr>
            <a:xfrm>
              <a:off x="2905471" y="4687144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2" name="Group 181"/>
            <p:cNvGrpSpPr/>
            <p:nvPr/>
          </p:nvGrpSpPr>
          <p:grpSpPr>
            <a:xfrm>
              <a:off x="2315577" y="3005267"/>
              <a:ext cx="563416" cy="368592"/>
              <a:chOff x="965450" y="3115553"/>
              <a:chExt cx="563416" cy="368592"/>
            </a:xfrm>
          </p:grpSpPr>
          <p:sp>
            <p:nvSpPr>
              <p:cNvPr id="183" name="Rectangle 182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4" name="TextBox 183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85" name="TextBox 184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86" name="Rectangle 185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207" name="Rectangle 206"/>
          <p:cNvSpPr/>
          <p:nvPr/>
        </p:nvSpPr>
        <p:spPr>
          <a:xfrm>
            <a:off x="88724" y="23730"/>
            <a:ext cx="800016" cy="2756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4 Fig</a:t>
            </a:r>
            <a:endParaRPr lang="en-US" sz="12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610A937-F691-4D06-B0DE-0364AE5AF617}"/>
              </a:ext>
            </a:extLst>
          </p:cNvPr>
          <p:cNvGrpSpPr/>
          <p:nvPr/>
        </p:nvGrpSpPr>
        <p:grpSpPr>
          <a:xfrm>
            <a:off x="202913" y="448344"/>
            <a:ext cx="1783433" cy="2133493"/>
            <a:chOff x="167513" y="447585"/>
            <a:chExt cx="1783433" cy="2133493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A74E6AC-EFC1-45EE-91FE-BB9A0E65DF0B}"/>
                </a:ext>
              </a:extLst>
            </p:cNvPr>
            <p:cNvSpPr txBox="1"/>
            <p:nvPr/>
          </p:nvSpPr>
          <p:spPr>
            <a:xfrm rot="16200000">
              <a:off x="-359394" y="1457746"/>
              <a:ext cx="1330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G (mg/g tissue)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00955" y="1746197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00978" y="131526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00364" y="871119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7E6FA13-F79D-4954-99CA-FC4547F7F4EB}"/>
                </a:ext>
              </a:extLst>
            </p:cNvPr>
            <p:cNvSpPr txBox="1"/>
            <p:nvPr/>
          </p:nvSpPr>
          <p:spPr>
            <a:xfrm>
              <a:off x="1061934" y="447585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graphicFrame>
          <p:nvGraphicFramePr>
            <p:cNvPr id="34" name="Object 3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94323263"/>
                </p:ext>
              </p:extLst>
            </p:nvPr>
          </p:nvGraphicFramePr>
          <p:xfrm>
            <a:off x="588661" y="723020"/>
            <a:ext cx="1362285" cy="173649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69" name="Prism 9" r:id="rId9" imgW="2292984" imgH="1498601" progId="Prism9.Document">
                    <p:embed/>
                  </p:oleObj>
                </mc:Choice>
                <mc:Fallback>
                  <p:oleObj name="Prism 9" r:id="rId9" imgW="2292984" imgH="1498601" progId="Prism9.Document">
                    <p:embed/>
                    <p:pic>
                      <p:nvPicPr>
                        <p:cNvPr id="231" name="Object 230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88661" y="723020"/>
                          <a:ext cx="1362285" cy="173649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0" name="TextBox 39"/>
            <p:cNvSpPr txBox="1"/>
            <p:nvPr/>
          </p:nvSpPr>
          <p:spPr>
            <a:xfrm>
              <a:off x="732323" y="2030735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966038" y="2028625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254276" y="1241977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515354" y="1065086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146809" y="230407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706573" y="229455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46" name="Straight Connector 145"/>
            <p:cNvCxnSpPr/>
            <p:nvPr/>
          </p:nvCxnSpPr>
          <p:spPr>
            <a:xfrm>
              <a:off x="797893" y="2357867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>
              <a:off x="1301529" y="2357867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8" name="Group 207"/>
            <p:cNvGrpSpPr/>
            <p:nvPr/>
          </p:nvGrpSpPr>
          <p:grpSpPr>
            <a:xfrm>
              <a:off x="717500" y="724249"/>
              <a:ext cx="563416" cy="368592"/>
              <a:chOff x="965450" y="3115553"/>
              <a:chExt cx="563416" cy="368592"/>
            </a:xfrm>
          </p:grpSpPr>
          <p:sp>
            <p:nvSpPr>
              <p:cNvPr id="209" name="Rectangle 208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212" name="Rectangle 211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62754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37</TotalTime>
  <Words>84</Words>
  <Application>Microsoft Office PowerPoint</Application>
  <PresentationFormat>On-screen Show (4:3)</PresentationFormat>
  <Paragraphs>5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Ailing J.</dc:creator>
  <cp:lastModifiedBy>Shridas, Preetha</cp:lastModifiedBy>
  <cp:revision>350</cp:revision>
  <cp:lastPrinted>2021-08-24T18:46:38Z</cp:lastPrinted>
  <dcterms:created xsi:type="dcterms:W3CDTF">2021-01-22T15:40:04Z</dcterms:created>
  <dcterms:modified xsi:type="dcterms:W3CDTF">2022-01-28T16:23:49Z</dcterms:modified>
</cp:coreProperties>
</file>